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303" r:id="rId3"/>
    <p:sldId id="301" r:id="rId4"/>
    <p:sldId id="27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56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D21950-EE7B-499E-929D-E9E10CC4625F}" v="96" dt="2025-12-01T16:06:42.9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91" d="100"/>
          <a:sy n="91" d="100"/>
        </p:scale>
        <p:origin x="11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cob Brown" userId="18a5bb8a-813a-40af-a010-8f933870b8a6" providerId="ADAL" clId="{9E50079D-569A-4C36-8B9F-159D7DDE901F}"/>
    <pc:docChg chg="custSel addSld delSld modSld">
      <pc:chgData name="Jacob Brown" userId="18a5bb8a-813a-40af-a010-8f933870b8a6" providerId="ADAL" clId="{9E50079D-569A-4C36-8B9F-159D7DDE901F}" dt="2025-12-01T16:06:56.783" v="341" actId="1076"/>
      <pc:docMkLst>
        <pc:docMk/>
      </pc:docMkLst>
      <pc:sldChg chg="addSp delSp modSp mod">
        <pc:chgData name="Jacob Brown" userId="18a5bb8a-813a-40af-a010-8f933870b8a6" providerId="ADAL" clId="{9E50079D-569A-4C36-8B9F-159D7DDE901F}" dt="2025-11-21T15:40:27.469" v="317" actId="1076"/>
        <pc:sldMkLst>
          <pc:docMk/>
          <pc:sldMk cId="3503036232" sldId="270"/>
        </pc:sldMkLst>
        <pc:spChg chg="mod">
          <ac:chgData name="Jacob Brown" userId="18a5bb8a-813a-40af-a010-8f933870b8a6" providerId="ADAL" clId="{9E50079D-569A-4C36-8B9F-159D7DDE901F}" dt="2025-11-20T14:58:54.606" v="258" actId="1076"/>
          <ac:spMkLst>
            <pc:docMk/>
            <pc:sldMk cId="3503036232" sldId="270"/>
            <ac:spMk id="6" creationId="{CC0CE7A6-3125-478F-2FA7-894BCA8B3834}"/>
          </ac:spMkLst>
        </pc:spChg>
        <pc:spChg chg="mod">
          <ac:chgData name="Jacob Brown" userId="18a5bb8a-813a-40af-a010-8f933870b8a6" providerId="ADAL" clId="{9E50079D-569A-4C36-8B9F-159D7DDE901F}" dt="2025-11-20T14:59:03.489" v="261" actId="1076"/>
          <ac:spMkLst>
            <pc:docMk/>
            <pc:sldMk cId="3503036232" sldId="270"/>
            <ac:spMk id="7" creationId="{C1A20522-1BA9-BAE9-9C27-489AC0FD85AC}"/>
          </ac:spMkLst>
        </pc:spChg>
        <pc:spChg chg="add mod">
          <ac:chgData name="Jacob Brown" userId="18a5bb8a-813a-40af-a010-8f933870b8a6" providerId="ADAL" clId="{9E50079D-569A-4C36-8B9F-159D7DDE901F}" dt="2025-11-21T14:00:43.151" v="281" actId="1076"/>
          <ac:spMkLst>
            <pc:docMk/>
            <pc:sldMk cId="3503036232" sldId="270"/>
            <ac:spMk id="8" creationId="{61EF8258-4338-A3D9-E1DB-666D25262862}"/>
          </ac:spMkLst>
        </pc:spChg>
        <pc:spChg chg="mod">
          <ac:chgData name="Jacob Brown" userId="18a5bb8a-813a-40af-a010-8f933870b8a6" providerId="ADAL" clId="{9E50079D-569A-4C36-8B9F-159D7DDE901F}" dt="2025-11-20T14:59:34.593" v="267" actId="1076"/>
          <ac:spMkLst>
            <pc:docMk/>
            <pc:sldMk cId="3503036232" sldId="270"/>
            <ac:spMk id="9" creationId="{0CAD127A-1D98-1405-994D-6F995BC35985}"/>
          </ac:spMkLst>
        </pc:spChg>
        <pc:spChg chg="mod">
          <ac:chgData name="Jacob Brown" userId="18a5bb8a-813a-40af-a010-8f933870b8a6" providerId="ADAL" clId="{9E50079D-569A-4C36-8B9F-159D7DDE901F}" dt="2025-11-20T14:59:16.009" v="264" actId="1076"/>
          <ac:spMkLst>
            <pc:docMk/>
            <pc:sldMk cId="3503036232" sldId="270"/>
            <ac:spMk id="11" creationId="{CAF18759-1F8F-3EEF-BC45-090C5F8A00D4}"/>
          </ac:spMkLst>
        </pc:spChg>
        <pc:spChg chg="mod">
          <ac:chgData name="Jacob Brown" userId="18a5bb8a-813a-40af-a010-8f933870b8a6" providerId="ADAL" clId="{9E50079D-569A-4C36-8B9F-159D7DDE901F}" dt="2025-11-20T14:59:49.771" v="270" actId="1076"/>
          <ac:spMkLst>
            <pc:docMk/>
            <pc:sldMk cId="3503036232" sldId="270"/>
            <ac:spMk id="12" creationId="{F5816119-EF30-4016-33E6-1FA65CB9B83B}"/>
          </ac:spMkLst>
        </pc:spChg>
        <pc:graphicFrameChg chg="mod">
          <ac:chgData name="Jacob Brown" userId="18a5bb8a-813a-40af-a010-8f933870b8a6" providerId="ADAL" clId="{9E50079D-569A-4C36-8B9F-159D7DDE901F}" dt="2025-11-20T14:59:42.244" v="268" actId="1076"/>
          <ac:graphicFrameMkLst>
            <pc:docMk/>
            <pc:sldMk cId="3503036232" sldId="270"/>
            <ac:graphicFrameMk id="5" creationId="{13D9F4E4-2608-7A04-ADC7-B044F18CD98B}"/>
          </ac:graphicFrameMkLst>
        </pc:graphicFrameChg>
        <pc:graphicFrameChg chg="add mod">
          <ac:chgData name="Jacob Brown" userId="18a5bb8a-813a-40af-a010-8f933870b8a6" providerId="ADAL" clId="{9E50079D-569A-4C36-8B9F-159D7DDE901F}" dt="2025-11-21T14:00:46.270" v="282" actId="1076"/>
          <ac:graphicFrameMkLst>
            <pc:docMk/>
            <pc:sldMk cId="3503036232" sldId="270"/>
            <ac:graphicFrameMk id="13" creationId="{F3D3C858-E72F-0356-C869-47311EB93347}"/>
          </ac:graphicFrameMkLst>
        </pc:graphicFrameChg>
        <pc:graphicFrameChg chg="add mod">
          <ac:chgData name="Jacob Brown" userId="18a5bb8a-813a-40af-a010-8f933870b8a6" providerId="ADAL" clId="{9E50079D-569A-4C36-8B9F-159D7DDE901F}" dt="2025-11-21T15:38:01.144" v="291" actId="1076"/>
          <ac:graphicFrameMkLst>
            <pc:docMk/>
            <pc:sldMk cId="3503036232" sldId="270"/>
            <ac:graphicFrameMk id="14" creationId="{80090640-49EB-0BEF-8703-155EA6FDA72C}"/>
          </ac:graphicFrameMkLst>
        </pc:graphicFrameChg>
        <pc:graphicFrameChg chg="add mod">
          <ac:chgData name="Jacob Brown" userId="18a5bb8a-813a-40af-a010-8f933870b8a6" providerId="ADAL" clId="{9E50079D-569A-4C36-8B9F-159D7DDE901F}" dt="2025-11-21T15:38:41.723" v="301" actId="1076"/>
          <ac:graphicFrameMkLst>
            <pc:docMk/>
            <pc:sldMk cId="3503036232" sldId="270"/>
            <ac:graphicFrameMk id="15" creationId="{E80EBEA8-6FC5-C3A4-F128-91114878A590}"/>
          </ac:graphicFrameMkLst>
        </pc:graphicFrameChg>
        <pc:graphicFrameChg chg="add mod">
          <ac:chgData name="Jacob Brown" userId="18a5bb8a-813a-40af-a010-8f933870b8a6" providerId="ADAL" clId="{9E50079D-569A-4C36-8B9F-159D7DDE901F}" dt="2025-11-21T15:39:43.933" v="309" actId="1076"/>
          <ac:graphicFrameMkLst>
            <pc:docMk/>
            <pc:sldMk cId="3503036232" sldId="270"/>
            <ac:graphicFrameMk id="16" creationId="{CF248BBB-3841-1CBC-60F6-B318760D12FF}"/>
          </ac:graphicFrameMkLst>
        </pc:graphicFrameChg>
        <pc:graphicFrameChg chg="add mod">
          <ac:chgData name="Jacob Brown" userId="18a5bb8a-813a-40af-a010-8f933870b8a6" providerId="ADAL" clId="{9E50079D-569A-4C36-8B9F-159D7DDE901F}" dt="2025-11-21T15:40:27.469" v="317" actId="1076"/>
          <ac:graphicFrameMkLst>
            <pc:docMk/>
            <pc:sldMk cId="3503036232" sldId="270"/>
            <ac:graphicFrameMk id="17" creationId="{A7155F97-6694-20A7-154C-67F7B2247999}"/>
          </ac:graphicFrameMkLst>
        </pc:graphicFrameChg>
      </pc:sldChg>
      <pc:sldChg chg="addSp delSp modSp add mod">
        <pc:chgData name="Jacob Brown" userId="18a5bb8a-813a-40af-a010-8f933870b8a6" providerId="ADAL" clId="{9E50079D-569A-4C36-8B9F-159D7DDE901F}" dt="2025-12-01T16:06:56.783" v="341" actId="1076"/>
        <pc:sldMkLst>
          <pc:docMk/>
          <pc:sldMk cId="305541350" sldId="301"/>
        </pc:sldMkLst>
        <pc:spChg chg="mod">
          <ac:chgData name="Jacob Brown" userId="18a5bb8a-813a-40af-a010-8f933870b8a6" providerId="ADAL" clId="{9E50079D-569A-4C36-8B9F-159D7DDE901F}" dt="2025-11-17T21:23:44.961" v="143" actId="1076"/>
          <ac:spMkLst>
            <pc:docMk/>
            <pc:sldMk cId="305541350" sldId="301"/>
            <ac:spMk id="3" creationId="{E50601C2-D484-9C6D-32ED-9A2E21BBB40E}"/>
          </ac:spMkLst>
        </pc:spChg>
        <pc:spChg chg="mod">
          <ac:chgData name="Jacob Brown" userId="18a5bb8a-813a-40af-a010-8f933870b8a6" providerId="ADAL" clId="{9E50079D-569A-4C36-8B9F-159D7DDE901F}" dt="2025-11-17T21:24:42.859" v="166" actId="1076"/>
          <ac:spMkLst>
            <pc:docMk/>
            <pc:sldMk cId="305541350" sldId="301"/>
            <ac:spMk id="4" creationId="{BC8D8BB7-1F54-AB24-2A37-2EAF2DDF7238}"/>
          </ac:spMkLst>
        </pc:spChg>
        <pc:spChg chg="mod">
          <ac:chgData name="Jacob Brown" userId="18a5bb8a-813a-40af-a010-8f933870b8a6" providerId="ADAL" clId="{9E50079D-569A-4C36-8B9F-159D7DDE901F}" dt="2025-11-17T21:22:40.077" v="120" actId="1076"/>
          <ac:spMkLst>
            <pc:docMk/>
            <pc:sldMk cId="305541350" sldId="301"/>
            <ac:spMk id="5" creationId="{BBD6986E-0E69-A59E-6194-F2AA0E952AFF}"/>
          </ac:spMkLst>
        </pc:spChg>
        <pc:spChg chg="mod">
          <ac:chgData name="Jacob Brown" userId="18a5bb8a-813a-40af-a010-8f933870b8a6" providerId="ADAL" clId="{9E50079D-569A-4C36-8B9F-159D7DDE901F}" dt="2025-11-17T21:22:36.335" v="119" actId="1076"/>
          <ac:spMkLst>
            <pc:docMk/>
            <pc:sldMk cId="305541350" sldId="301"/>
            <ac:spMk id="6" creationId="{33F0ED70-E43C-9E79-BE28-FE811BC5FB1F}"/>
          </ac:spMkLst>
        </pc:spChg>
        <pc:spChg chg="mod">
          <ac:chgData name="Jacob Brown" userId="18a5bb8a-813a-40af-a010-8f933870b8a6" providerId="ADAL" clId="{9E50079D-569A-4C36-8B9F-159D7DDE901F}" dt="2025-12-01T16:06:06.358" v="324" actId="1076"/>
          <ac:spMkLst>
            <pc:docMk/>
            <pc:sldMk cId="305541350" sldId="301"/>
            <ac:spMk id="7" creationId="{89E5BE05-5A43-D29E-C443-5A305EC9AC1A}"/>
          </ac:spMkLst>
        </pc:spChg>
        <pc:spChg chg="mod">
          <ac:chgData name="Jacob Brown" userId="18a5bb8a-813a-40af-a010-8f933870b8a6" providerId="ADAL" clId="{9E50079D-569A-4C36-8B9F-159D7DDE901F}" dt="2025-11-17T21:21:14.599" v="97" actId="1076"/>
          <ac:spMkLst>
            <pc:docMk/>
            <pc:sldMk cId="305541350" sldId="301"/>
            <ac:spMk id="8" creationId="{3CAA6AF4-FF13-1BC7-72FB-7A2FD2B30CD6}"/>
          </ac:spMkLst>
        </pc:spChg>
        <pc:spChg chg="mod">
          <ac:chgData name="Jacob Brown" userId="18a5bb8a-813a-40af-a010-8f933870b8a6" providerId="ADAL" clId="{9E50079D-569A-4C36-8B9F-159D7DDE901F}" dt="2025-11-17T21:24:37.211" v="165" actId="1076"/>
          <ac:spMkLst>
            <pc:docMk/>
            <pc:sldMk cId="305541350" sldId="301"/>
            <ac:spMk id="10" creationId="{C0C13625-4A2E-CB19-F438-CC8722E4894D}"/>
          </ac:spMkLst>
        </pc:spChg>
        <pc:graphicFrameChg chg="add mod">
          <ac:chgData name="Jacob Brown" userId="18a5bb8a-813a-40af-a010-8f933870b8a6" providerId="ADAL" clId="{9E50079D-569A-4C36-8B9F-159D7DDE901F}" dt="2025-12-01T16:05:56.272" v="322" actId="1076"/>
          <ac:graphicFrameMkLst>
            <pc:docMk/>
            <pc:sldMk cId="305541350" sldId="301"/>
            <ac:graphicFrameMk id="2" creationId="{B6FEA084-B558-A894-09FC-BAB9BB924896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50.277" v="338" actId="1076"/>
          <ac:graphicFrameMkLst>
            <pc:docMk/>
            <pc:sldMk cId="305541350" sldId="301"/>
            <ac:graphicFrameMk id="13" creationId="{07BB1E7B-4594-4005-B3E9-7B58B582C5A1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08.295" v="325" actId="1076"/>
          <ac:graphicFrameMkLst>
            <pc:docMk/>
            <pc:sldMk cId="305541350" sldId="301"/>
            <ac:graphicFrameMk id="14" creationId="{9D61CF6D-BDF9-CD4B-B740-82509DD428C0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11.659" v="326" actId="1076"/>
          <ac:graphicFrameMkLst>
            <pc:docMk/>
            <pc:sldMk cId="305541350" sldId="301"/>
            <ac:graphicFrameMk id="15" creationId="{0D364AFF-982B-179B-D90A-F7856B5D5395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17.147" v="327" actId="1076"/>
          <ac:graphicFrameMkLst>
            <pc:docMk/>
            <pc:sldMk cId="305541350" sldId="301"/>
            <ac:graphicFrameMk id="16" creationId="{9737D4BD-100C-8AC4-56C1-D2E579A8AFC0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51.841" v="339" actId="1076"/>
          <ac:graphicFrameMkLst>
            <pc:docMk/>
            <pc:sldMk cId="305541350" sldId="301"/>
            <ac:graphicFrameMk id="17" creationId="{767FFEED-C582-121C-CEB2-108975A7A4F7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53.832" v="340" actId="1076"/>
          <ac:graphicFrameMkLst>
            <pc:docMk/>
            <pc:sldMk cId="305541350" sldId="301"/>
            <ac:graphicFrameMk id="18" creationId="{85F3198E-538F-7B3A-821E-D091439B4296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00.552" v="323" actId="1076"/>
          <ac:graphicFrameMkLst>
            <pc:docMk/>
            <pc:sldMk cId="305541350" sldId="301"/>
            <ac:graphicFrameMk id="19" creationId="{C4FCDECF-AAC1-1E8C-5DE3-28D9B37A9B96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44.763" v="337" actId="1076"/>
          <ac:graphicFrameMkLst>
            <pc:docMk/>
            <pc:sldMk cId="305541350" sldId="301"/>
            <ac:graphicFrameMk id="20" creationId="{041435DB-0A8A-59B2-161A-7004FA640A81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23.765" v="115" actId="1076"/>
          <ac:graphicFrameMkLst>
            <pc:docMk/>
            <pc:sldMk cId="305541350" sldId="301"/>
            <ac:graphicFrameMk id="21" creationId="{2CBE6EC1-4961-CBF7-4E34-9715DFCC00D6}"/>
          </ac:graphicFrameMkLst>
        </pc:graphicFrameChg>
        <pc:graphicFrameChg chg="mod">
          <ac:chgData name="Jacob Brown" userId="18a5bb8a-813a-40af-a010-8f933870b8a6" providerId="ADAL" clId="{9E50079D-569A-4C36-8B9F-159D7DDE901F}" dt="2025-12-01T16:06:56.783" v="341" actId="1076"/>
          <ac:graphicFrameMkLst>
            <pc:docMk/>
            <pc:sldMk cId="305541350" sldId="301"/>
            <ac:graphicFrameMk id="22" creationId="{2D7FACC0-B83A-A027-8F60-D8BF5C5684B2}"/>
          </ac:graphicFrameMkLst>
        </pc:graphicFrameChg>
        <pc:graphicFrameChg chg="mod">
          <ac:chgData name="Jacob Brown" userId="18a5bb8a-813a-40af-a010-8f933870b8a6" providerId="ADAL" clId="{9E50079D-569A-4C36-8B9F-159D7DDE901F}" dt="2025-11-17T21:23:15.570" v="136" actId="1076"/>
          <ac:graphicFrameMkLst>
            <pc:docMk/>
            <pc:sldMk cId="305541350" sldId="301"/>
            <ac:graphicFrameMk id="23" creationId="{D594F18C-5C06-E70D-367F-B8D91BE7E18B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12.610" v="112" actId="1076"/>
          <ac:graphicFrameMkLst>
            <pc:docMk/>
            <pc:sldMk cId="305541350" sldId="301"/>
            <ac:graphicFrameMk id="24" creationId="{162C04E3-28F2-8BD8-CF4F-3A27129B1535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10.695" v="111" actId="1076"/>
          <ac:graphicFrameMkLst>
            <pc:docMk/>
            <pc:sldMk cId="305541350" sldId="301"/>
            <ac:graphicFrameMk id="25" creationId="{FA7669D0-B078-B45C-47D7-4B19DC914ECD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21.483" v="114" actId="1076"/>
          <ac:graphicFrameMkLst>
            <pc:docMk/>
            <pc:sldMk cId="305541350" sldId="301"/>
            <ac:graphicFrameMk id="26" creationId="{44195CCE-69C5-DDDC-550A-93801216C923}"/>
          </ac:graphicFrameMkLst>
        </pc:graphicFrameChg>
        <pc:graphicFrameChg chg="mod">
          <ac:chgData name="Jacob Brown" userId="18a5bb8a-813a-40af-a010-8f933870b8a6" providerId="ADAL" clId="{9E50079D-569A-4C36-8B9F-159D7DDE901F}" dt="2025-11-17T21:23:11.161" v="135" actId="1076"/>
          <ac:graphicFrameMkLst>
            <pc:docMk/>
            <pc:sldMk cId="305541350" sldId="301"/>
            <ac:graphicFrameMk id="27" creationId="{BA898CF7-0A3F-1CDD-EFC5-A8F0ADDE8A44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17.489" v="113" actId="1076"/>
          <ac:graphicFrameMkLst>
            <pc:docMk/>
            <pc:sldMk cId="305541350" sldId="301"/>
            <ac:graphicFrameMk id="28" creationId="{77F63BBC-53A0-31DA-3318-A7CC01844CBD}"/>
          </ac:graphicFrameMkLst>
        </pc:graphicFrameChg>
        <pc:graphicFrameChg chg="mod">
          <ac:chgData name="Jacob Brown" userId="18a5bb8a-813a-40af-a010-8f933870b8a6" providerId="ADAL" clId="{9E50079D-569A-4C36-8B9F-159D7DDE901F}" dt="2025-11-17T21:22:30.147" v="118" actId="1076"/>
          <ac:graphicFrameMkLst>
            <pc:docMk/>
            <pc:sldMk cId="305541350" sldId="301"/>
            <ac:graphicFrameMk id="29" creationId="{6A137E9B-AE14-C946-3D77-2E40D3539D12}"/>
          </ac:graphicFrameMkLst>
        </pc:graphicFrameChg>
        <pc:graphicFrameChg chg="add mod">
          <ac:chgData name="Jacob Brown" userId="18a5bb8a-813a-40af-a010-8f933870b8a6" providerId="ADAL" clId="{9E50079D-569A-4C36-8B9F-159D7DDE901F}" dt="2025-11-17T21:24:59.661" v="172" actId="1076"/>
          <ac:graphicFrameMkLst>
            <pc:docMk/>
            <pc:sldMk cId="305541350" sldId="301"/>
            <ac:graphicFrameMk id="30" creationId="{7EA556DB-F7D2-B761-1B22-D78223143995}"/>
          </ac:graphicFrameMkLst>
        </pc:graphicFrameChg>
      </pc:sldChg>
      <pc:sldChg chg="addSp delSp modSp add mod">
        <pc:chgData name="Jacob Brown" userId="18a5bb8a-813a-40af-a010-8f933870b8a6" providerId="ADAL" clId="{9E50079D-569A-4C36-8B9F-159D7DDE901F}" dt="2025-11-19T21:48:32.097" v="257" actId="20577"/>
        <pc:sldMkLst>
          <pc:docMk/>
          <pc:sldMk cId="4128729545" sldId="303"/>
        </pc:sldMkLst>
        <pc:spChg chg="add mod">
          <ac:chgData name="Jacob Brown" userId="18a5bb8a-813a-40af-a010-8f933870b8a6" providerId="ADAL" clId="{9E50079D-569A-4C36-8B9F-159D7DDE901F}" dt="2025-11-19T21:47:35.868" v="237" actId="1076"/>
          <ac:spMkLst>
            <pc:docMk/>
            <pc:sldMk cId="4128729545" sldId="303"/>
            <ac:spMk id="9" creationId="{154323BF-BA31-EE0B-1821-031B62A2E345}"/>
          </ac:spMkLst>
        </pc:spChg>
        <pc:spChg chg="add mod">
          <ac:chgData name="Jacob Brown" userId="18a5bb8a-813a-40af-a010-8f933870b8a6" providerId="ADAL" clId="{9E50079D-569A-4C36-8B9F-159D7DDE901F}" dt="2025-11-19T21:47:41.688" v="241" actId="20577"/>
          <ac:spMkLst>
            <pc:docMk/>
            <pc:sldMk cId="4128729545" sldId="303"/>
            <ac:spMk id="10" creationId="{6A2D90D9-FCF1-ACC3-F015-75677E3FE3DF}"/>
          </ac:spMkLst>
        </pc:spChg>
        <pc:spChg chg="add mod">
          <ac:chgData name="Jacob Brown" userId="18a5bb8a-813a-40af-a010-8f933870b8a6" providerId="ADAL" clId="{9E50079D-569A-4C36-8B9F-159D7DDE901F}" dt="2025-11-19T21:47:51.866" v="245" actId="20577"/>
          <ac:spMkLst>
            <pc:docMk/>
            <pc:sldMk cId="4128729545" sldId="303"/>
            <ac:spMk id="11" creationId="{BC765C77-C8AF-C8F8-FDC7-1B84EAAF6810}"/>
          </ac:spMkLst>
        </pc:spChg>
        <pc:spChg chg="add mod">
          <ac:chgData name="Jacob Brown" userId="18a5bb8a-813a-40af-a010-8f933870b8a6" providerId="ADAL" clId="{9E50079D-569A-4C36-8B9F-159D7DDE901F}" dt="2025-11-19T21:48:01.873" v="249" actId="20577"/>
          <ac:spMkLst>
            <pc:docMk/>
            <pc:sldMk cId="4128729545" sldId="303"/>
            <ac:spMk id="12" creationId="{5D56235B-02D5-70ED-EF53-8D5CAF9DCBDE}"/>
          </ac:spMkLst>
        </pc:spChg>
        <pc:spChg chg="add mod">
          <ac:chgData name="Jacob Brown" userId="18a5bb8a-813a-40af-a010-8f933870b8a6" providerId="ADAL" clId="{9E50079D-569A-4C36-8B9F-159D7DDE901F}" dt="2025-11-19T21:48:16.507" v="253" actId="20577"/>
          <ac:spMkLst>
            <pc:docMk/>
            <pc:sldMk cId="4128729545" sldId="303"/>
            <ac:spMk id="13" creationId="{63E3764D-4208-D36E-C23D-2677BAE513E6}"/>
          </ac:spMkLst>
        </pc:spChg>
        <pc:spChg chg="add mod">
          <ac:chgData name="Jacob Brown" userId="18a5bb8a-813a-40af-a010-8f933870b8a6" providerId="ADAL" clId="{9E50079D-569A-4C36-8B9F-159D7DDE901F}" dt="2025-11-19T21:48:32.097" v="257" actId="20577"/>
          <ac:spMkLst>
            <pc:docMk/>
            <pc:sldMk cId="4128729545" sldId="303"/>
            <ac:spMk id="14" creationId="{B2D3E420-075B-FF84-09D1-A49C4EB61194}"/>
          </ac:spMkLst>
        </pc:spChg>
        <pc:graphicFrameChg chg="add mod">
          <ac:chgData name="Jacob Brown" userId="18a5bb8a-813a-40af-a010-8f933870b8a6" providerId="ADAL" clId="{9E50079D-569A-4C36-8B9F-159D7DDE901F}" dt="2025-11-19T21:45:38.326" v="207" actId="1076"/>
          <ac:graphicFrameMkLst>
            <pc:docMk/>
            <pc:sldMk cId="4128729545" sldId="303"/>
            <ac:graphicFrameMk id="2" creationId="{6E2C35C2-1A30-7EA1-F766-5D4B2C5A05B6}"/>
          </ac:graphicFrameMkLst>
        </pc:graphicFrameChg>
        <pc:graphicFrameChg chg="add mod">
          <ac:chgData name="Jacob Brown" userId="18a5bb8a-813a-40af-a010-8f933870b8a6" providerId="ADAL" clId="{9E50079D-569A-4C36-8B9F-159D7DDE901F}" dt="2025-11-19T21:45:44.130" v="208" actId="1076"/>
          <ac:graphicFrameMkLst>
            <pc:docMk/>
            <pc:sldMk cId="4128729545" sldId="303"/>
            <ac:graphicFrameMk id="3" creationId="{491BB677-3DB0-D809-7977-029738176C20}"/>
          </ac:graphicFrameMkLst>
        </pc:graphicFrameChg>
        <pc:graphicFrameChg chg="add mod">
          <ac:chgData name="Jacob Brown" userId="18a5bb8a-813a-40af-a010-8f933870b8a6" providerId="ADAL" clId="{9E50079D-569A-4C36-8B9F-159D7DDE901F}" dt="2025-11-19T21:47:00.067" v="225" actId="1076"/>
          <ac:graphicFrameMkLst>
            <pc:docMk/>
            <pc:sldMk cId="4128729545" sldId="303"/>
            <ac:graphicFrameMk id="4" creationId="{C2A28D62-52A9-D530-0A31-9C6EE387E003}"/>
          </ac:graphicFrameMkLst>
        </pc:graphicFrameChg>
        <pc:graphicFrameChg chg="add mod">
          <ac:chgData name="Jacob Brown" userId="18a5bb8a-813a-40af-a010-8f933870b8a6" providerId="ADAL" clId="{9E50079D-569A-4C36-8B9F-159D7DDE901F}" dt="2025-11-19T21:47:03.645" v="226" actId="1076"/>
          <ac:graphicFrameMkLst>
            <pc:docMk/>
            <pc:sldMk cId="4128729545" sldId="303"/>
            <ac:graphicFrameMk id="5" creationId="{9348F0A7-C802-5408-8FA0-7960E3B72703}"/>
          </ac:graphicFrameMkLst>
        </pc:graphicFrameChg>
        <pc:graphicFrameChg chg="add mod">
          <ac:chgData name="Jacob Brown" userId="18a5bb8a-813a-40af-a010-8f933870b8a6" providerId="ADAL" clId="{9E50079D-569A-4C36-8B9F-159D7DDE901F}" dt="2025-11-19T21:46:39.785" v="220" actId="1076"/>
          <ac:graphicFrameMkLst>
            <pc:docMk/>
            <pc:sldMk cId="4128729545" sldId="303"/>
            <ac:graphicFrameMk id="6" creationId="{3E992D9E-C5BB-003C-4F14-CBE4497C8E2B}"/>
          </ac:graphicFrameMkLst>
        </pc:graphicFrameChg>
        <pc:graphicFrameChg chg="add mod">
          <ac:chgData name="Jacob Brown" userId="18a5bb8a-813a-40af-a010-8f933870b8a6" providerId="ADAL" clId="{9E50079D-569A-4C36-8B9F-159D7DDE901F}" dt="2025-11-19T21:47:08.886" v="227" actId="1076"/>
          <ac:graphicFrameMkLst>
            <pc:docMk/>
            <pc:sldMk cId="4128729545" sldId="303"/>
            <ac:graphicFrameMk id="8" creationId="{EA64CE22-3A9A-4969-1092-8FC04890ABE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2A0E82-7377-4D35-9252-416E3FD4932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511123-E795-42F9-A911-12B5CC3269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9499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AD062-590F-A0B8-C90E-9CEAF3EBC8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7546B1-F2DD-A79A-0703-1A9EA3ECAA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0B535D-582E-EA10-74AD-5BEED3167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4A7AC5-5BBA-EE90-F516-9A51D2D81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25E30-ECB8-8498-0293-E9B861CEE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632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0D59F-8D70-9509-1F96-4F9179B17F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7474BA-EC40-16D8-22CF-EFBFC342AE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490E11-7F93-6FE2-12B9-96EEF75CA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B8EF71-861D-39B3-FD08-834B742D1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168C4B-5262-5B86-6B3C-B61D756DC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301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706A4F-0A47-5B59-C6E2-B923BBF86F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0AE83F-2085-FC11-79C0-C80715FFF0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522FB7-A655-E56B-D859-8F3650376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E69516-8499-F8B9-A43E-B841E9BBC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2236F1-3A3B-527D-50FA-1DCAB696D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33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979BE-BC78-8FD3-4E4A-5D57E2DF50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644A57-55A3-3E09-FA31-B325C8500D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2AE7A-A80A-970B-CFA7-E8E76177A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6FB558-128E-F715-942C-083503D4E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DAD63-F942-09B8-58CE-AE00E4182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269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1FD72-529A-79D0-B2CA-66B907270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151456-EC92-0742-10C9-83416885DA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E95F0-1547-801C-F1E5-7C9B4BD1A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FC69EF-E862-C0DF-3EA1-52B0A652B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9D638-128F-B1E4-6BCE-C496E28CA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040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96BD80-A503-ABE2-438C-75711773C9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D1EB7B-C21B-600B-075E-A3FCC90A0D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604657-7735-32B2-4E50-A909960E2F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5A7D37-0A07-DD6B-FA66-1159550B1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A0CB5-14ED-3FEC-4502-9C03B0507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8F50BF-EA2D-AD9C-8482-11E453CA4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643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4F5BA-CC73-4CB0-1864-59C72939F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0EC970-8B9F-6AB1-749D-7C2B81FCE3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2E74E0-5B81-4C59-0D69-3BD607B1A1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071411-E833-1095-F805-767D25FFC3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732B3E-0008-3DB7-0B3B-18ECFA751F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54E9E3-459B-BD8A-ED3C-CD74AF2AF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9CCE61-CCB5-F0C0-F5F6-FD3B459B5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8A072D-CAA8-92E8-44E4-E1BDB5ACA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434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B6A91-EEEB-F6FE-736E-1BE8F95FE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532CC1-7BC1-5B28-CB04-770DAB4CC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D1E969A-E40A-8AFA-88AC-1A1E65DFC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6D7982-2A56-5C1A-6E47-0C16B373E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630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F18D482-2CB5-E6C6-D867-B29B1E888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2E338F-0D72-384A-7244-496540790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5C2118-99B9-A147-14AD-AA85F53F2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275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4D461-E786-14FC-0EA2-4FA9F870D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C2EC27-F488-8F83-64D1-F006DEDDCF2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4F4AA3-F1BC-CEA0-F468-AF4416AC61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CB8145-E146-AAB7-274C-DB947DD56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6A3BF8-7594-D5D5-BA23-F65CA59172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74A457-E2A6-2354-7067-BE1F3BB62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99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3A63A-004D-5D74-E5A9-0AF6FF289A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AC54BE-A17E-9439-25FD-A8BDE0609D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EE28B9-6B83-89FD-E603-23BB64A731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D10AA9-AC1F-C642-F386-88AA70BEE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0FE26F-59EE-8B12-AF81-AE0B47B5B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4578E0-7743-5618-6227-68727A822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807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166FF8-5155-E645-FE0B-BB6818A78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95D4DF-FD28-535F-DDD4-94B181EEC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F4C052-07A0-EFFB-CE81-F0C07D7A4C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CB0377-5044-49B4-9745-C0F4D629BB4D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8D073D-5F26-FB71-F5CF-631791D1B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63FC9-9842-E376-690D-5AE608494D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527349-9A1A-4A65-B5D2-73A819BE0B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384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12" Type="http://schemas.openxmlformats.org/officeDocument/2006/relationships/oleObject" Target="../embeddings/oleObject12.bin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1.emf"/><Relationship Id="rId5" Type="http://schemas.openxmlformats.org/officeDocument/2006/relationships/image" Target="../media/image8.emf"/><Relationship Id="rId10" Type="http://schemas.openxmlformats.org/officeDocument/2006/relationships/oleObject" Target="../embeddings/oleObject11.bin"/><Relationship Id="rId4" Type="http://schemas.openxmlformats.org/officeDocument/2006/relationships/oleObject" Target="../embeddings/oleObject8.bin"/><Relationship Id="rId9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8.emf"/><Relationship Id="rId18" Type="http://schemas.openxmlformats.org/officeDocument/2006/relationships/oleObject" Target="../embeddings/oleObject21.bin"/><Relationship Id="rId26" Type="http://schemas.openxmlformats.org/officeDocument/2006/relationships/oleObject" Target="../embeddings/oleObject25.bin"/><Relationship Id="rId39" Type="http://schemas.openxmlformats.org/officeDocument/2006/relationships/image" Target="../media/image31.emf"/><Relationship Id="rId21" Type="http://schemas.openxmlformats.org/officeDocument/2006/relationships/image" Target="../media/image22.emf"/><Relationship Id="rId34" Type="http://schemas.openxmlformats.org/officeDocument/2006/relationships/oleObject" Target="../embeddings/oleObject29.bin"/><Relationship Id="rId7" Type="http://schemas.openxmlformats.org/officeDocument/2006/relationships/image" Target="../media/image15.emf"/><Relationship Id="rId12" Type="http://schemas.openxmlformats.org/officeDocument/2006/relationships/oleObject" Target="../embeddings/oleObject18.bin"/><Relationship Id="rId17" Type="http://schemas.openxmlformats.org/officeDocument/2006/relationships/image" Target="../media/image20.emf"/><Relationship Id="rId25" Type="http://schemas.openxmlformats.org/officeDocument/2006/relationships/image" Target="../media/image24.emf"/><Relationship Id="rId33" Type="http://schemas.openxmlformats.org/officeDocument/2006/relationships/image" Target="../media/image28.emf"/><Relationship Id="rId38" Type="http://schemas.openxmlformats.org/officeDocument/2006/relationships/oleObject" Target="../embeddings/oleObject31.bin"/><Relationship Id="rId2" Type="http://schemas.openxmlformats.org/officeDocument/2006/relationships/oleObject" Target="../embeddings/oleObject13.bin"/><Relationship Id="rId16" Type="http://schemas.openxmlformats.org/officeDocument/2006/relationships/oleObject" Target="../embeddings/oleObject20.bin"/><Relationship Id="rId20" Type="http://schemas.openxmlformats.org/officeDocument/2006/relationships/oleObject" Target="../embeddings/oleObject22.bin"/><Relationship Id="rId29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17.emf"/><Relationship Id="rId24" Type="http://schemas.openxmlformats.org/officeDocument/2006/relationships/oleObject" Target="../embeddings/oleObject24.bin"/><Relationship Id="rId32" Type="http://schemas.openxmlformats.org/officeDocument/2006/relationships/oleObject" Target="../embeddings/oleObject28.bin"/><Relationship Id="rId37" Type="http://schemas.openxmlformats.org/officeDocument/2006/relationships/image" Target="../media/image30.emf"/><Relationship Id="rId5" Type="http://schemas.openxmlformats.org/officeDocument/2006/relationships/image" Target="../media/image14.emf"/><Relationship Id="rId15" Type="http://schemas.openxmlformats.org/officeDocument/2006/relationships/image" Target="../media/image19.emf"/><Relationship Id="rId23" Type="http://schemas.openxmlformats.org/officeDocument/2006/relationships/image" Target="../media/image23.emf"/><Relationship Id="rId28" Type="http://schemas.openxmlformats.org/officeDocument/2006/relationships/oleObject" Target="../embeddings/oleObject26.bin"/><Relationship Id="rId36" Type="http://schemas.openxmlformats.org/officeDocument/2006/relationships/oleObject" Target="../embeddings/oleObject30.bin"/><Relationship Id="rId10" Type="http://schemas.openxmlformats.org/officeDocument/2006/relationships/oleObject" Target="../embeddings/oleObject17.bin"/><Relationship Id="rId19" Type="http://schemas.openxmlformats.org/officeDocument/2006/relationships/image" Target="../media/image21.emf"/><Relationship Id="rId31" Type="http://schemas.openxmlformats.org/officeDocument/2006/relationships/image" Target="../media/image27.emf"/><Relationship Id="rId4" Type="http://schemas.openxmlformats.org/officeDocument/2006/relationships/oleObject" Target="../embeddings/oleObject14.bin"/><Relationship Id="rId9" Type="http://schemas.openxmlformats.org/officeDocument/2006/relationships/image" Target="../media/image16.emf"/><Relationship Id="rId14" Type="http://schemas.openxmlformats.org/officeDocument/2006/relationships/oleObject" Target="../embeddings/oleObject19.bin"/><Relationship Id="rId22" Type="http://schemas.openxmlformats.org/officeDocument/2006/relationships/oleObject" Target="../embeddings/oleObject23.bin"/><Relationship Id="rId27" Type="http://schemas.openxmlformats.org/officeDocument/2006/relationships/image" Target="../media/image25.emf"/><Relationship Id="rId30" Type="http://schemas.openxmlformats.org/officeDocument/2006/relationships/oleObject" Target="../embeddings/oleObject27.bin"/><Relationship Id="rId35" Type="http://schemas.openxmlformats.org/officeDocument/2006/relationships/image" Target="../media/image29.emf"/><Relationship Id="rId8" Type="http://schemas.openxmlformats.org/officeDocument/2006/relationships/oleObject" Target="../embeddings/oleObject16.bin"/><Relationship Id="rId3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oleObject" Target="../embeddings/oleObject32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3D9F4E4-2608-7A04-ADC7-B044F18CD9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9930644"/>
              </p:ext>
            </p:extLst>
          </p:nvPr>
        </p:nvGraphicFramePr>
        <p:xfrm>
          <a:off x="6975302" y="512905"/>
          <a:ext cx="2889250" cy="294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889009" imgH="2946266" progId="Prism10.Document">
                  <p:embed/>
                </p:oleObj>
              </mc:Choice>
              <mc:Fallback>
                <p:oleObj name="Prism 10" r:id="rId2" imgW="2889009" imgH="294626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13D9F4E4-2608-7A04-ADC7-B044F18CD9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75302" y="512905"/>
                        <a:ext cx="2889250" cy="294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CC0CE7A6-3125-478F-2FA7-894BCA8B3834}"/>
              </a:ext>
            </a:extLst>
          </p:cNvPr>
          <p:cNvSpPr txBox="1"/>
          <p:nvPr/>
        </p:nvSpPr>
        <p:spPr>
          <a:xfrm>
            <a:off x="117006" y="236618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A20522-1BA9-BAE9-9C27-489AC0FD85AC}"/>
              </a:ext>
            </a:extLst>
          </p:cNvPr>
          <p:cNvSpPr txBox="1"/>
          <p:nvPr/>
        </p:nvSpPr>
        <p:spPr>
          <a:xfrm>
            <a:off x="2619562" y="236618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AD127A-1D98-1405-994D-6F995BC35985}"/>
              </a:ext>
            </a:extLst>
          </p:cNvPr>
          <p:cNvSpPr txBox="1"/>
          <p:nvPr/>
        </p:nvSpPr>
        <p:spPr>
          <a:xfrm>
            <a:off x="7086488" y="236618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F18759-1F8F-3EEF-BC45-090C5F8A00D4}"/>
              </a:ext>
            </a:extLst>
          </p:cNvPr>
          <p:cNvSpPr txBox="1"/>
          <p:nvPr/>
        </p:nvSpPr>
        <p:spPr>
          <a:xfrm>
            <a:off x="4886824" y="236618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816119-EF30-4016-33E6-1FA65CB9B83B}"/>
              </a:ext>
            </a:extLst>
          </p:cNvPr>
          <p:cNvSpPr txBox="1"/>
          <p:nvPr/>
        </p:nvSpPr>
        <p:spPr>
          <a:xfrm>
            <a:off x="9329236" y="236618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EF8258-4338-A3D9-E1DB-666D25262862}"/>
              </a:ext>
            </a:extLst>
          </p:cNvPr>
          <p:cNvSpPr txBox="1"/>
          <p:nvPr/>
        </p:nvSpPr>
        <p:spPr>
          <a:xfrm>
            <a:off x="4054720" y="3627185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F3D3C858-E72F-0356-C869-47311EB933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0159856"/>
              </p:ext>
            </p:extLst>
          </p:nvPr>
        </p:nvGraphicFramePr>
        <p:xfrm>
          <a:off x="4240039" y="3585177"/>
          <a:ext cx="2735263" cy="337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735231" imgH="3378605" progId="Prism10.Document">
                  <p:embed/>
                </p:oleObj>
              </mc:Choice>
              <mc:Fallback>
                <p:oleObj name="Prism 10" r:id="rId4" imgW="2735231" imgH="3378605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3D3C858-E72F-0356-C869-47311EB933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40039" y="3585177"/>
                        <a:ext cx="2735263" cy="337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80090640-49EB-0BEF-8703-155EA6FDA7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94914265"/>
              </p:ext>
            </p:extLst>
          </p:nvPr>
        </p:nvGraphicFramePr>
        <p:xfrm>
          <a:off x="-91589" y="489092"/>
          <a:ext cx="2941637" cy="299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942309" imgH="2994321" progId="Prism10.Document">
                  <p:embed/>
                </p:oleObj>
              </mc:Choice>
              <mc:Fallback>
                <p:oleObj name="Prism 10" r:id="rId6" imgW="2942309" imgH="2994321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80090640-49EB-0BEF-8703-155EA6FDA7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91589" y="489092"/>
                        <a:ext cx="2941637" cy="299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E80EBEA8-6FC5-C3A4-F128-91114878A5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5736900"/>
              </p:ext>
            </p:extLst>
          </p:nvPr>
        </p:nvGraphicFramePr>
        <p:xfrm>
          <a:off x="2225951" y="340201"/>
          <a:ext cx="2791366" cy="31429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950232" imgH="3320620" progId="Prism10.Document">
                  <p:embed/>
                </p:oleObj>
              </mc:Choice>
              <mc:Fallback>
                <p:oleObj name="Prism 10" r:id="rId8" imgW="2950232" imgH="3320620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E80EBEA8-6FC5-C3A4-F128-91114878A5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25951" y="340201"/>
                        <a:ext cx="2791366" cy="31429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CF248BBB-3841-1CBC-60F6-B318760D12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1932827"/>
              </p:ext>
            </p:extLst>
          </p:nvPr>
        </p:nvGraphicFramePr>
        <p:xfrm>
          <a:off x="4385282" y="552284"/>
          <a:ext cx="2949575" cy="2960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950232" imgH="2960826" progId="Prism10.Document">
                  <p:embed/>
                </p:oleObj>
              </mc:Choice>
              <mc:Fallback>
                <p:oleObj name="Prism 10" r:id="rId10" imgW="2950232" imgH="2960826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CF248BBB-3841-1CBC-60F6-B318760D12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385282" y="552284"/>
                        <a:ext cx="2949575" cy="2960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A7155F97-6694-20A7-154C-67F7B22479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3703828"/>
              </p:ext>
            </p:extLst>
          </p:nvPr>
        </p:nvGraphicFramePr>
        <p:xfrm>
          <a:off x="9412605" y="504967"/>
          <a:ext cx="2874963" cy="2978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2875324" imgH="2977754" progId="Prism10.Document">
                  <p:embed/>
                </p:oleObj>
              </mc:Choice>
              <mc:Fallback>
                <p:oleObj name="Prism 10" r:id="rId12" imgW="2875324" imgH="2977754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A7155F97-6694-20A7-154C-67F7B22479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412605" y="504967"/>
                        <a:ext cx="2874963" cy="2978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03036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E2C35C2-1A30-7EA1-F766-5D4B2C5A05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7661474"/>
              </p:ext>
            </p:extLst>
          </p:nvPr>
        </p:nvGraphicFramePr>
        <p:xfrm>
          <a:off x="896747" y="278511"/>
          <a:ext cx="2955925" cy="2989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955994" imgH="2989999" progId="Prism10.Document">
                  <p:embed/>
                </p:oleObj>
              </mc:Choice>
              <mc:Fallback>
                <p:oleObj name="Prism 10" r:id="rId2" imgW="2955994" imgH="298999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E2C35C2-1A30-7EA1-F766-5D4B2C5A05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96747" y="278511"/>
                        <a:ext cx="2955925" cy="2989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491BB677-3DB0-D809-7977-029738176C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3289509"/>
              </p:ext>
            </p:extLst>
          </p:nvPr>
        </p:nvGraphicFramePr>
        <p:xfrm>
          <a:off x="3614611" y="251523"/>
          <a:ext cx="3032125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032343" imgH="2971631" progId="Prism10.Document">
                  <p:embed/>
                </p:oleObj>
              </mc:Choice>
              <mc:Fallback>
                <p:oleObj name="Prism 10" r:id="rId4" imgW="3032343" imgH="2971631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491BB677-3DB0-D809-7977-029738176C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14611" y="251523"/>
                        <a:ext cx="3032125" cy="29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2A28D62-52A9-D530-0A31-9C6EE387E0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7270570"/>
              </p:ext>
            </p:extLst>
          </p:nvPr>
        </p:nvGraphicFramePr>
        <p:xfrm>
          <a:off x="3690811" y="3223323"/>
          <a:ext cx="2955925" cy="2989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955994" imgH="2989999" progId="Prism10.Document">
                  <p:embed/>
                </p:oleObj>
              </mc:Choice>
              <mc:Fallback>
                <p:oleObj name="Prism 10" r:id="rId6" imgW="2955994" imgH="2989999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2A28D62-52A9-D530-0A31-9C6EE387E0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90811" y="3223323"/>
                        <a:ext cx="2955925" cy="2989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348F0A7-C802-5408-8FA0-7960E3B727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2048115"/>
              </p:ext>
            </p:extLst>
          </p:nvPr>
        </p:nvGraphicFramePr>
        <p:xfrm>
          <a:off x="6174168" y="3205860"/>
          <a:ext cx="3032125" cy="296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032343" imgH="2962267" progId="Prism10.Document">
                  <p:embed/>
                </p:oleObj>
              </mc:Choice>
              <mc:Fallback>
                <p:oleObj name="Prism 10" r:id="rId8" imgW="3032343" imgH="2962267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348F0A7-C802-5408-8FA0-7960E3B727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174168" y="3205860"/>
                        <a:ext cx="3032125" cy="296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E992D9E-C5BB-003C-4F14-CBE4497C8E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2425303"/>
              </p:ext>
            </p:extLst>
          </p:nvPr>
        </p:nvGraphicFramePr>
        <p:xfrm>
          <a:off x="6174169" y="251523"/>
          <a:ext cx="3032125" cy="2935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32343" imgH="2934895" progId="Prism10.Document">
                  <p:embed/>
                </p:oleObj>
              </mc:Choice>
              <mc:Fallback>
                <p:oleObj name="Prism 10" r:id="rId10" imgW="3032343" imgH="2934895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E992D9E-C5BB-003C-4F14-CBE4497C8E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174169" y="251523"/>
                        <a:ext cx="3032125" cy="2935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A64CE22-3A9A-4969-1092-8FC04890AB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2661572"/>
              </p:ext>
            </p:extLst>
          </p:nvPr>
        </p:nvGraphicFramePr>
        <p:xfrm>
          <a:off x="972947" y="3259836"/>
          <a:ext cx="2955925" cy="295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2955994" imgH="2953263" progId="Prism10.Document">
                  <p:embed/>
                </p:oleObj>
              </mc:Choice>
              <mc:Fallback>
                <p:oleObj name="Prism 10" r:id="rId12" imgW="2955994" imgH="295326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EA64CE22-3A9A-4969-1092-8FC04890AB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972947" y="3259836"/>
                        <a:ext cx="2955925" cy="295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154323BF-BA31-EE0B-1821-031B62A2E345}"/>
              </a:ext>
            </a:extLst>
          </p:cNvPr>
          <p:cNvSpPr txBox="1"/>
          <p:nvPr/>
        </p:nvSpPr>
        <p:spPr>
          <a:xfrm>
            <a:off x="1293114" y="276082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2D90D9-FCF1-ACC3-F015-75677E3FE3DF}"/>
              </a:ext>
            </a:extLst>
          </p:cNvPr>
          <p:cNvSpPr txBox="1"/>
          <p:nvPr/>
        </p:nvSpPr>
        <p:spPr>
          <a:xfrm>
            <a:off x="3928872" y="276082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C765C77-C8AF-C8F8-FDC7-1B84EAAF6810}"/>
              </a:ext>
            </a:extLst>
          </p:cNvPr>
          <p:cNvSpPr txBox="1"/>
          <p:nvPr/>
        </p:nvSpPr>
        <p:spPr>
          <a:xfrm>
            <a:off x="6639205" y="281741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56235B-02D5-70ED-EF53-8D5CAF9DCBDE}"/>
              </a:ext>
            </a:extLst>
          </p:cNvPr>
          <p:cNvSpPr txBox="1"/>
          <p:nvPr/>
        </p:nvSpPr>
        <p:spPr>
          <a:xfrm>
            <a:off x="1293114" y="3186810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E3764D-4208-D36E-C23D-2677BAE513E6}"/>
              </a:ext>
            </a:extLst>
          </p:cNvPr>
          <p:cNvSpPr txBox="1"/>
          <p:nvPr/>
        </p:nvSpPr>
        <p:spPr>
          <a:xfrm>
            <a:off x="3928872" y="3205860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2D3E420-075B-FF84-09D1-A49C4EB61194}"/>
              </a:ext>
            </a:extLst>
          </p:cNvPr>
          <p:cNvSpPr txBox="1"/>
          <p:nvPr/>
        </p:nvSpPr>
        <p:spPr>
          <a:xfrm>
            <a:off x="6639205" y="3211519"/>
            <a:ext cx="4245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</p:spTree>
    <p:extLst>
      <p:ext uri="{BB962C8B-B14F-4D97-AF65-F5344CB8AC3E}">
        <p14:creationId xmlns:p14="http://schemas.microsoft.com/office/powerpoint/2010/main" val="4128729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50601C2-D484-9C6D-32ED-9A2E21BBB40E}"/>
              </a:ext>
            </a:extLst>
          </p:cNvPr>
          <p:cNvSpPr txBox="1"/>
          <p:nvPr/>
        </p:nvSpPr>
        <p:spPr>
          <a:xfrm>
            <a:off x="7969932" y="-10886"/>
            <a:ext cx="19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uto-oxidati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C8D8BB7-1F54-AB24-2A37-2EAF2DDF7238}"/>
              </a:ext>
            </a:extLst>
          </p:cNvPr>
          <p:cNvSpPr txBox="1"/>
          <p:nvPr/>
        </p:nvSpPr>
        <p:spPr>
          <a:xfrm>
            <a:off x="5947979" y="3847548"/>
            <a:ext cx="58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2D7FACC0-B83A-A027-8F60-D8BF5C5684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0549991"/>
              </p:ext>
            </p:extLst>
          </p:nvPr>
        </p:nvGraphicFramePr>
        <p:xfrm>
          <a:off x="5698999" y="308411"/>
          <a:ext cx="1914500" cy="18294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71958" imgH="2934895" progId="Prism10.Document">
                  <p:embed/>
                </p:oleObj>
              </mc:Choice>
              <mc:Fallback>
                <p:oleObj name="Prism 10" r:id="rId2" imgW="3071958" imgH="2934895" progId="Prism10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2D7FACC0-B83A-A027-8F60-D8BF5C5684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98999" y="308411"/>
                        <a:ext cx="1914500" cy="18294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85F3198E-538F-7B3A-821E-D091439B42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3162154"/>
              </p:ext>
            </p:extLst>
          </p:nvPr>
        </p:nvGraphicFramePr>
        <p:xfrm>
          <a:off x="7438231" y="183155"/>
          <a:ext cx="2133822" cy="20143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148306" imgH="2971631" progId="Prism10.Document">
                  <p:embed/>
                </p:oleObj>
              </mc:Choice>
              <mc:Fallback>
                <p:oleObj name="Prism 10" r:id="rId4" imgW="3148306" imgH="2971631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85F3198E-538F-7B3A-821E-D091439B42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438231" y="183155"/>
                        <a:ext cx="2133822" cy="20143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041435DB-0A8A-59B2-161A-7004FA640A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3133923"/>
              </p:ext>
            </p:extLst>
          </p:nvPr>
        </p:nvGraphicFramePr>
        <p:xfrm>
          <a:off x="6705246" y="2157988"/>
          <a:ext cx="1792421" cy="17377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071958" imgH="2977754" progId="Prism10.Document">
                  <p:embed/>
                </p:oleObj>
              </mc:Choice>
              <mc:Fallback>
                <p:oleObj name="Prism 10" r:id="rId6" imgW="3071958" imgH="2977754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041435DB-0A8A-59B2-161A-7004FA640A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705246" y="2157988"/>
                        <a:ext cx="1792421" cy="17377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BD6986E-0E69-A59E-6194-F2AA0E952AFF}"/>
              </a:ext>
            </a:extLst>
          </p:cNvPr>
          <p:cNvSpPr txBox="1"/>
          <p:nvPr/>
        </p:nvSpPr>
        <p:spPr>
          <a:xfrm>
            <a:off x="-49390" y="3223197"/>
            <a:ext cx="58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3F0ED70-E43C-9E79-BE28-FE811BC5FB1F}"/>
              </a:ext>
            </a:extLst>
          </p:cNvPr>
          <p:cNvSpPr txBox="1"/>
          <p:nvPr/>
        </p:nvSpPr>
        <p:spPr>
          <a:xfrm>
            <a:off x="1917456" y="3223197"/>
            <a:ext cx="19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ytochrome p45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E5BE05-5A43-D29E-C443-5A305EC9AC1A}"/>
              </a:ext>
            </a:extLst>
          </p:cNvPr>
          <p:cNvSpPr txBox="1"/>
          <p:nvPr/>
        </p:nvSpPr>
        <p:spPr>
          <a:xfrm>
            <a:off x="1801003" y="-30143"/>
            <a:ext cx="19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Lipoxygenas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AA6AF4-FF13-1BC7-72FB-7A2FD2B30CD6}"/>
              </a:ext>
            </a:extLst>
          </p:cNvPr>
          <p:cNvSpPr txBox="1"/>
          <p:nvPr/>
        </p:nvSpPr>
        <p:spPr>
          <a:xfrm>
            <a:off x="5919899" y="44922"/>
            <a:ext cx="58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B45B2C-4A88-CC10-ACB0-323DE977110A}"/>
              </a:ext>
            </a:extLst>
          </p:cNvPr>
          <p:cNvSpPr txBox="1"/>
          <p:nvPr/>
        </p:nvSpPr>
        <p:spPr>
          <a:xfrm>
            <a:off x="0" y="-10886"/>
            <a:ext cx="58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0C13625-4A2E-CB19-F438-CC8722E4894D}"/>
              </a:ext>
            </a:extLst>
          </p:cNvPr>
          <p:cNvSpPr txBox="1"/>
          <p:nvPr/>
        </p:nvSpPr>
        <p:spPr>
          <a:xfrm>
            <a:off x="7743065" y="3847548"/>
            <a:ext cx="1914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yclo-oxygenase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C4FCDECF-AAC1-1E8C-5DE3-28D9B37A9B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7699357"/>
              </p:ext>
            </p:extLst>
          </p:nvPr>
        </p:nvGraphicFramePr>
        <p:xfrm>
          <a:off x="3293541" y="1833435"/>
          <a:ext cx="1639790" cy="15347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148306" imgH="2947141" progId="Prism10.Document">
                  <p:embed/>
                </p:oleObj>
              </mc:Choice>
              <mc:Fallback>
                <p:oleObj name="Prism 10" r:id="rId8" imgW="3148306" imgH="2947141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C4FCDECF-AAC1-1E8C-5DE3-28D9B37A9B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93541" y="1833435"/>
                        <a:ext cx="1639790" cy="15347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594F18C-5C06-E70D-367F-B8D91BE7E1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0633093"/>
              </p:ext>
            </p:extLst>
          </p:nvPr>
        </p:nvGraphicFramePr>
        <p:xfrm>
          <a:off x="1672693" y="1711224"/>
          <a:ext cx="1771855" cy="1685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071958" imgH="2922650" progId="Prism10.Document">
                  <p:embed/>
                </p:oleObj>
              </mc:Choice>
              <mc:Fallback>
                <p:oleObj name="Prism 10" r:id="rId10" imgW="3071958" imgH="2922650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D594F18C-5C06-E70D-367F-B8D91BE7E1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672693" y="1711224"/>
                        <a:ext cx="1771855" cy="1685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07BB1E7B-4594-4005-B3E9-7B58B582C5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1625866"/>
              </p:ext>
            </p:extLst>
          </p:nvPr>
        </p:nvGraphicFramePr>
        <p:xfrm>
          <a:off x="8552882" y="2113711"/>
          <a:ext cx="1877198" cy="18238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071958" imgH="2983876" progId="Prism10.Document">
                  <p:embed/>
                </p:oleObj>
              </mc:Choice>
              <mc:Fallback>
                <p:oleObj name="Prism 10" r:id="rId12" imgW="3071958" imgH="2983876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07BB1E7B-4594-4005-B3E9-7B58B582C5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552882" y="2113711"/>
                        <a:ext cx="1877198" cy="18238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9D61CF6D-BDF9-CD4B-B740-82509DD428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3462932"/>
              </p:ext>
            </p:extLst>
          </p:nvPr>
        </p:nvGraphicFramePr>
        <p:xfrm>
          <a:off x="3217895" y="228033"/>
          <a:ext cx="1804049" cy="1685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148306" imgH="2941018" progId="Prism10.Document">
                  <p:embed/>
                </p:oleObj>
              </mc:Choice>
              <mc:Fallback>
                <p:oleObj name="Prism 10" r:id="rId14" imgW="3148306" imgH="2941018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9D61CF6D-BDF9-CD4B-B740-82509DD428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217895" y="228033"/>
                        <a:ext cx="1804049" cy="1685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0D364AFF-982B-179B-D90A-F7856B5D53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7438773"/>
              </p:ext>
            </p:extLst>
          </p:nvPr>
        </p:nvGraphicFramePr>
        <p:xfrm>
          <a:off x="1716999" y="169890"/>
          <a:ext cx="1771855" cy="17031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071958" imgH="2953263" progId="Prism10.Document">
                  <p:embed/>
                </p:oleObj>
              </mc:Choice>
              <mc:Fallback>
                <p:oleObj name="Prism 10" r:id="rId16" imgW="3071958" imgH="2953263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0D364AFF-982B-179B-D90A-F7856B5D53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716999" y="169890"/>
                        <a:ext cx="1771855" cy="17031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737D4BD-100C-8AC4-56C1-D2E579A8AF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2761317"/>
              </p:ext>
            </p:extLst>
          </p:nvPr>
        </p:nvGraphicFramePr>
        <p:xfrm>
          <a:off x="155489" y="211071"/>
          <a:ext cx="1804049" cy="16785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3148306" imgH="2928773" progId="Prism10.Document">
                  <p:embed/>
                </p:oleObj>
              </mc:Choice>
              <mc:Fallback>
                <p:oleObj name="Prism 10" r:id="rId18" imgW="3148306" imgH="2928773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9737D4BD-100C-8AC4-56C1-D2E579A8AF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55489" y="211071"/>
                        <a:ext cx="1804049" cy="16785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67FFEED-C582-121C-CEB2-108975A7A4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5168995"/>
              </p:ext>
            </p:extLst>
          </p:nvPr>
        </p:nvGraphicFramePr>
        <p:xfrm>
          <a:off x="9421727" y="266978"/>
          <a:ext cx="2003479" cy="18640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0" imgW="3148306" imgH="2928773" progId="Prism10.Document">
                  <p:embed/>
                </p:oleObj>
              </mc:Choice>
              <mc:Fallback>
                <p:oleObj name="Prism 10" r:id="rId20" imgW="3148306" imgH="2928773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67FFEED-C582-121C-CEB2-108975A7A4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9421727" y="266978"/>
                        <a:ext cx="2003479" cy="18640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2CBE6EC1-4961-CBF7-4E34-9715DFCC00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8535949"/>
              </p:ext>
            </p:extLst>
          </p:nvPr>
        </p:nvGraphicFramePr>
        <p:xfrm>
          <a:off x="1735882" y="3421059"/>
          <a:ext cx="2010643" cy="19088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3071958" imgH="2916527" progId="Prism10.Document">
                  <p:embed/>
                </p:oleObj>
              </mc:Choice>
              <mc:Fallback>
                <p:oleObj name="Prism 10" r:id="rId22" imgW="3071958" imgH="2916527" progId="Prism10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2CBE6EC1-4961-CBF7-4E34-9715DFCC00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735882" y="3421059"/>
                        <a:ext cx="2010643" cy="19088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162C04E3-28F2-8BD8-CF4F-3A27129B15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465148"/>
              </p:ext>
            </p:extLst>
          </p:nvPr>
        </p:nvGraphicFramePr>
        <p:xfrm>
          <a:off x="3295605" y="5147745"/>
          <a:ext cx="1922678" cy="17888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3148306" imgH="2928773" progId="Prism10.Document">
                  <p:embed/>
                </p:oleObj>
              </mc:Choice>
              <mc:Fallback>
                <p:oleObj name="Prism 10" r:id="rId24" imgW="3148306" imgH="2928773" progId="Prism10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162C04E3-28F2-8BD8-CF4F-3A27129B15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3295605" y="5147745"/>
                        <a:ext cx="1922678" cy="17888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FA7669D0-B078-B45C-47D7-4B19DC914E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2423305"/>
              </p:ext>
            </p:extLst>
          </p:nvPr>
        </p:nvGraphicFramePr>
        <p:xfrm>
          <a:off x="1814923" y="5161044"/>
          <a:ext cx="1801982" cy="1777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6" imgW="2994168" imgH="2953263" progId="Prism10.Document">
                  <p:embed/>
                </p:oleObj>
              </mc:Choice>
              <mc:Fallback>
                <p:oleObj name="Prism 10" r:id="rId26" imgW="2994168" imgH="2953263" progId="Prism10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FA7669D0-B078-B45C-47D7-4B19DC914E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814923" y="5161044"/>
                        <a:ext cx="1801982" cy="1777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44195CCE-69C5-DDDC-550A-93801216C9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3602828"/>
              </p:ext>
            </p:extLst>
          </p:nvPr>
        </p:nvGraphicFramePr>
        <p:xfrm>
          <a:off x="158734" y="3523832"/>
          <a:ext cx="1798114" cy="17771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8" imgW="2994168" imgH="2959386" progId="Prism10.Document">
                  <p:embed/>
                </p:oleObj>
              </mc:Choice>
              <mc:Fallback>
                <p:oleObj name="Prism 10" r:id="rId28" imgW="2994168" imgH="2959386" progId="Prism10.Document">
                  <p:embed/>
                  <p:pic>
                    <p:nvPicPr>
                      <p:cNvPr id="26" name="Object 25">
                        <a:extLst>
                          <a:ext uri="{FF2B5EF4-FFF2-40B4-BE49-F238E27FC236}">
                            <a16:creationId xmlns:a16="http://schemas.microsoft.com/office/drawing/2014/main" id="{44195CCE-69C5-DDDC-550A-93801216C9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158734" y="3523832"/>
                        <a:ext cx="1798114" cy="17771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BA898CF7-0A3F-1CDD-EFC5-A8F0ADDE8A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8015870"/>
              </p:ext>
            </p:extLst>
          </p:nvPr>
        </p:nvGraphicFramePr>
        <p:xfrm>
          <a:off x="92473" y="1800290"/>
          <a:ext cx="1639790" cy="15864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0" imgW="3071958" imgH="2971631" progId="Prism10.Document">
                  <p:embed/>
                </p:oleObj>
              </mc:Choice>
              <mc:Fallback>
                <p:oleObj name="Prism 10" r:id="rId30" imgW="3071958" imgH="2971631" progId="Prism10.Document">
                  <p:embed/>
                  <p:pic>
                    <p:nvPicPr>
                      <p:cNvPr id="27" name="Object 26">
                        <a:extLst>
                          <a:ext uri="{FF2B5EF4-FFF2-40B4-BE49-F238E27FC236}">
                            <a16:creationId xmlns:a16="http://schemas.microsoft.com/office/drawing/2014/main" id="{BA898CF7-0A3F-1CDD-EFC5-A8F0ADDE8A4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92473" y="1800290"/>
                        <a:ext cx="1639790" cy="15864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>
            <a:extLst>
              <a:ext uri="{FF2B5EF4-FFF2-40B4-BE49-F238E27FC236}">
                <a16:creationId xmlns:a16="http://schemas.microsoft.com/office/drawing/2014/main" id="{77F63BBC-53A0-31DA-3318-A7CC01844C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6899266"/>
              </p:ext>
            </p:extLst>
          </p:nvPr>
        </p:nvGraphicFramePr>
        <p:xfrm>
          <a:off x="94322" y="5147745"/>
          <a:ext cx="1862526" cy="17404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2" imgW="3148306" imgH="2941018" progId="Prism10.Document">
                  <p:embed/>
                </p:oleObj>
              </mc:Choice>
              <mc:Fallback>
                <p:oleObj name="Prism 10" r:id="rId32" imgW="3148306" imgH="2941018" progId="Prism10.Document">
                  <p:embed/>
                  <p:pic>
                    <p:nvPicPr>
                      <p:cNvPr id="28" name="Object 27">
                        <a:extLst>
                          <a:ext uri="{FF2B5EF4-FFF2-40B4-BE49-F238E27FC236}">
                            <a16:creationId xmlns:a16="http://schemas.microsoft.com/office/drawing/2014/main" id="{77F63BBC-53A0-31DA-3318-A7CC01844CB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94322" y="5147745"/>
                        <a:ext cx="1862526" cy="17404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6A137E9B-AE14-C946-3D77-2E40D3539D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5507451"/>
              </p:ext>
            </p:extLst>
          </p:nvPr>
        </p:nvGraphicFramePr>
        <p:xfrm>
          <a:off x="3437530" y="3489795"/>
          <a:ext cx="1922678" cy="1811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4" imgW="3148306" imgH="2965508" progId="Prism10.Document">
                  <p:embed/>
                </p:oleObj>
              </mc:Choice>
              <mc:Fallback>
                <p:oleObj name="Prism 10" r:id="rId34" imgW="3148306" imgH="2965508" progId="Prism10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A137E9B-AE14-C946-3D77-2E40D3539D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3437530" y="3489795"/>
                        <a:ext cx="1922678" cy="1811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6FEA084-B558-A894-09FC-BAB9BB9248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4672085"/>
              </p:ext>
            </p:extLst>
          </p:nvPr>
        </p:nvGraphicFramePr>
        <p:xfrm>
          <a:off x="6523324" y="4395383"/>
          <a:ext cx="1974343" cy="199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6" imgW="2918180" imgH="2953263" progId="Prism10.Document">
                  <p:embed/>
                </p:oleObj>
              </mc:Choice>
              <mc:Fallback>
                <p:oleObj name="Prism 10" r:id="rId36" imgW="2918180" imgH="2953263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6FEA084-B558-A894-09FC-BAB9BB9248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6523324" y="4395383"/>
                        <a:ext cx="1974343" cy="199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7EA556DB-F7D2-B761-1B22-D782231439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0624530"/>
              </p:ext>
            </p:extLst>
          </p:nvPr>
        </p:nvGraphicFramePr>
        <p:xfrm>
          <a:off x="8339374" y="4488062"/>
          <a:ext cx="1877198" cy="1884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8" imgW="2918180" imgH="2928773" progId="Prism10.Document">
                  <p:embed/>
                </p:oleObj>
              </mc:Choice>
              <mc:Fallback>
                <p:oleObj name="Prism 10" r:id="rId38" imgW="2918180" imgH="2928773" progId="Prism10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7EA556DB-F7D2-B761-1B22-D782231439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8339374" y="4488062"/>
                        <a:ext cx="1877198" cy="18843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55413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1E2FD89-12B6-19E3-7002-9388AC6218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6968188"/>
              </p:ext>
            </p:extLst>
          </p:nvPr>
        </p:nvGraphicFramePr>
        <p:xfrm>
          <a:off x="3865944" y="87440"/>
          <a:ext cx="3068637" cy="637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069077" imgH="6372926" progId="Prism10.Document">
                  <p:embed/>
                </p:oleObj>
              </mc:Choice>
              <mc:Fallback>
                <p:oleObj name="Prism 10" r:id="rId2" imgW="3069077" imgH="6372926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1E2FD89-12B6-19E3-7002-9388AC6218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65944" y="87440"/>
                        <a:ext cx="3068637" cy="6372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79652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a36450eb-db06-42a7-8d1b-026719f701e3}" enabled="0" method="" siteId="{a36450eb-db06-42a7-8d1b-026719f701e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2160</TotalTime>
  <Words>37</Words>
  <Application>Microsoft Office PowerPoint</Application>
  <PresentationFormat>Widescreen</PresentationFormat>
  <Paragraphs>2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</vt:vector>
  </TitlesOfParts>
  <Company>Oklahoma Medical Research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cob Brown, PhD</dc:creator>
  <cp:lastModifiedBy>Jacob Brown</cp:lastModifiedBy>
  <cp:revision>50</cp:revision>
  <dcterms:created xsi:type="dcterms:W3CDTF">2025-03-17T20:15:33Z</dcterms:created>
  <dcterms:modified xsi:type="dcterms:W3CDTF">2025-12-01T16:07:04Z</dcterms:modified>
</cp:coreProperties>
</file>